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gif" ContentType="image/gif"/>
  <Override PartName="/ppt/media/image2.gif" ContentType="image/gi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DFCD5-9397-4B64-A493-6DFD9E256E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B87FC-8670-44D5-A0CB-4C5535BB68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5024C-E2EC-46BF-9FDC-232F3FB45B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CB9BB-B839-4B17-9909-F213AC0646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54680-2E07-41A6-855F-7101413CD2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4294A-8EA4-4BEC-83E7-BA8483E0EA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C982F-0EE3-43BA-8668-D0A4CC0A7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85181-8D90-49A7-9BD6-10DE8D4514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207E8-2381-499C-B18A-DC6D5197B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A1E86-4CC6-4794-8A00-23BE58AEC1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C0A24-A5E1-49E9-919C-0AFF1B49D4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6F93F-C4F2-4CD5-8AD0-13F48D7D98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F508A8-4D49-44BA-8602-10627FF080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image" Target="../media/image2.gi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Calibri"/>
              </a:rPr>
              <a:t>Cinematographic MRI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6840" y="1534680"/>
            <a:ext cx="404028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Short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4644720" y="1534680"/>
            <a:ext cx="404172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Long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itle 1"/>
          <p:cNvSpPr/>
          <p:nvPr/>
        </p:nvSpPr>
        <p:spPr>
          <a:xfrm>
            <a:off x="0" y="1125360"/>
            <a:ext cx="9144000" cy="44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800" spc="-1" strike="noStrike">
                <a:solidFill>
                  <a:srgbClr val="000000"/>
                </a:solidFill>
                <a:latin typeface="Calibri"/>
              </a:rPr>
              <a:t>Control mou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0" y="615636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1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Representative end diastolic short-axis and long-axis images from a control mous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9" descr="B:\Publications\articles\2011-04; Phenotyping (in prep)\03_submitted to Plos One\Supplementary material\control\Control_Cine_LA.gif"/>
          <p:cNvPicPr/>
          <p:nvPr/>
        </p:nvPicPr>
        <p:blipFill>
          <a:blip r:embed="rId1"/>
          <a:stretch/>
        </p:blipFill>
        <p:spPr>
          <a:xfrm flipH="1">
            <a:off x="4689360" y="2174760"/>
            <a:ext cx="3951360" cy="39513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0" descr="B:\Publications\articles\2011-04; Phenotyping (in prep)\03_submitted to Plos One\Supplementary material\control\Control_Cine_SA.gif"/>
          <p:cNvPicPr/>
          <p:nvPr/>
        </p:nvPicPr>
        <p:blipFill>
          <a:blip r:embed="rId2"/>
          <a:stretch/>
        </p:blipFill>
        <p:spPr>
          <a:xfrm flipH="1">
            <a:off x="501480" y="2174760"/>
            <a:ext cx="3951360" cy="395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2T11:30:18Z</dcterms:created>
  <dc:creator>B.J van Nierop</dc:creator>
  <dc:description/>
  <dc:language>en-US</dc:language>
  <cp:lastModifiedBy>B.J van Nierop</cp:lastModifiedBy>
  <dcterms:modified xsi:type="dcterms:W3CDTF">2013-01-06T12:23:21Z</dcterms:modified>
  <cp:revision>6</cp:revision>
  <dc:subject/>
  <dc:title>Cinematographic MRI</dc:title>
</cp:coreProperties>
</file>